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4" r:id="rId2"/>
    <p:sldId id="265" r:id="rId3"/>
    <p:sldId id="266" r:id="rId4"/>
  </p:sldIdLst>
  <p:sldSz cx="9144000" cy="9001125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46" y="230"/>
      </p:cViewPr>
      <p:guideLst>
        <p:guide orient="horz" pos="283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830680-0930-4484-8C01-FE6DE3623C40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687513" y="685800"/>
            <a:ext cx="34829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304474-922D-48F0-82B7-86CED314792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36120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1" y="2796183"/>
            <a:ext cx="7772400" cy="1929408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5100637"/>
            <a:ext cx="6400801" cy="230028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3328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1145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1" y="472978"/>
            <a:ext cx="2057400" cy="1008042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472978"/>
            <a:ext cx="6019800" cy="10080427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2162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5728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5784058"/>
            <a:ext cx="7772400" cy="178772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3815063"/>
            <a:ext cx="7772400" cy="19689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26849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2756596"/>
            <a:ext cx="4038600" cy="779680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1" y="2756596"/>
            <a:ext cx="4038600" cy="779680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9819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360462"/>
            <a:ext cx="8229601" cy="1500188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2014836"/>
            <a:ext cx="4040188" cy="83968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854524"/>
            <a:ext cx="4040188" cy="51860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6" y="2014836"/>
            <a:ext cx="4041775" cy="83968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6" y="2854524"/>
            <a:ext cx="4041775" cy="51860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7218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3927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1007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2" y="358378"/>
            <a:ext cx="3008313" cy="15251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1" y="358380"/>
            <a:ext cx="5111750" cy="768221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2" y="1883570"/>
            <a:ext cx="3008313" cy="615702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65205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9" y="6300788"/>
            <a:ext cx="5486400" cy="74384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9" y="804268"/>
            <a:ext cx="5486400" cy="540067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9" y="7044632"/>
            <a:ext cx="5486400" cy="105638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6612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360462"/>
            <a:ext cx="8229601" cy="1500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2100263"/>
            <a:ext cx="8229601" cy="59403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8342710"/>
            <a:ext cx="2133601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30E9B-C199-4C1F-8C0A-475A06E310AE}" type="datetimeFigureOut">
              <a:rPr lang="it-IT" smtClean="0"/>
              <a:t>01/07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1" y="8342710"/>
            <a:ext cx="2895600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8342710"/>
            <a:ext cx="2133601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34CE1-77DC-4D7C-A907-6262FE6B29A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05575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07504" y="239886"/>
            <a:ext cx="89289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Figure S1: Microarray validation and concordance with Real Time results </a:t>
            </a:r>
            <a:r>
              <a:rPr lang="en-GB" sz="1200" dirty="0"/>
              <a:t>(A) Relative gene expression analysis 24h following aphid infestation. The graph displays the relative quantity (RQ) of each target gene in infested plants </a:t>
            </a:r>
            <a:r>
              <a:rPr lang="en-US" sz="1200" dirty="0"/>
              <a:t>relative to the calibrator control plants. </a:t>
            </a:r>
            <a:r>
              <a:rPr lang="en-GB" sz="1200" dirty="0"/>
              <a:t>Asterisks indicate that the 2</a:t>
            </a:r>
            <a:r>
              <a:rPr lang="en-GB" sz="1200" baseline="30000" dirty="0"/>
              <a:t>-</a:t>
            </a:r>
            <a:r>
              <a:rPr lang="en-GB" sz="1200" baseline="30000" dirty="0">
                <a:sym typeface="Symbol"/>
              </a:rPr>
              <a:t></a:t>
            </a:r>
            <a:r>
              <a:rPr lang="en-GB" sz="1200" baseline="30000" dirty="0"/>
              <a:t>Ct</a:t>
            </a:r>
            <a:r>
              <a:rPr lang="en-GB" sz="1200" dirty="0"/>
              <a:t> values were significantly different from the calibrator (</a:t>
            </a:r>
            <a:r>
              <a:rPr lang="en-GB" sz="1200" i="1" dirty="0"/>
              <a:t>p</a:t>
            </a:r>
            <a:r>
              <a:rPr lang="en-GB" sz="1200" dirty="0"/>
              <a:t>&lt; 0.01; Student’s </a:t>
            </a:r>
            <a:r>
              <a:rPr lang="en-GB" sz="1200" i="1" dirty="0"/>
              <a:t>t</a:t>
            </a:r>
            <a:r>
              <a:rPr lang="en-GB" sz="1200" dirty="0"/>
              <a:t>-test). (B</a:t>
            </a:r>
            <a:r>
              <a:rPr lang="en-US" sz="1200" dirty="0"/>
              <a:t>) The graph displays the concordance between microarray fold change and Real Time RQ values on a linear </a:t>
            </a:r>
            <a:r>
              <a:rPr lang="en-US" sz="1200" dirty="0" smtClean="0"/>
              <a:t>scale</a:t>
            </a:r>
            <a:endParaRPr lang="it-IT" sz="1200" dirty="0"/>
          </a:p>
        </p:txBody>
      </p:sp>
      <p:grpSp>
        <p:nvGrpSpPr>
          <p:cNvPr id="3" name="Gruppo 2"/>
          <p:cNvGrpSpPr/>
          <p:nvPr/>
        </p:nvGrpSpPr>
        <p:grpSpPr>
          <a:xfrm>
            <a:off x="539552" y="2412330"/>
            <a:ext cx="8424936" cy="3168352"/>
            <a:chOff x="539552" y="2412330"/>
            <a:chExt cx="8424936" cy="3168352"/>
          </a:xfrm>
        </p:grpSpPr>
        <p:pic>
          <p:nvPicPr>
            <p:cNvPr id="5" name="Immagine 4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9552" y="2412330"/>
              <a:ext cx="8424936" cy="316835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" name="CasellaDiTesto 1"/>
            <p:cNvSpPr txBox="1"/>
            <p:nvPr/>
          </p:nvSpPr>
          <p:spPr>
            <a:xfrm rot="19593960">
              <a:off x="1801732" y="5128862"/>
              <a:ext cx="86472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 smtClean="0">
                  <a:latin typeface="Arial" pitchFamily="34" charset="0"/>
                  <a:cs typeface="Arial" pitchFamily="34" charset="0"/>
                </a:rPr>
                <a:t>WRKY 46</a:t>
              </a:r>
              <a:endParaRPr lang="it-IT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422378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179512" y="324098"/>
            <a:ext cx="843628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Figure S2: Microarray validation and concordance with Real Time results </a:t>
            </a:r>
            <a:r>
              <a:rPr lang="en-GB" sz="1200" dirty="0"/>
              <a:t>(C) Relative gene expression analysis 48h following aphid infestation. The graph displays the relative quantity (RQ) of each target gene in infested plants </a:t>
            </a:r>
            <a:r>
              <a:rPr lang="en-US" sz="1200" dirty="0"/>
              <a:t>relative to the calibrator control plants. </a:t>
            </a:r>
            <a:r>
              <a:rPr lang="en-GB" sz="1200" dirty="0"/>
              <a:t>Asterisks indicate that the 2</a:t>
            </a:r>
            <a:r>
              <a:rPr lang="en-GB" sz="1200" baseline="30000" dirty="0"/>
              <a:t>-</a:t>
            </a:r>
            <a:r>
              <a:rPr lang="en-GB" sz="1200" baseline="30000" dirty="0">
                <a:sym typeface="Symbol"/>
              </a:rPr>
              <a:t></a:t>
            </a:r>
            <a:r>
              <a:rPr lang="en-GB" sz="1200" baseline="30000" dirty="0"/>
              <a:t>Ct</a:t>
            </a:r>
            <a:r>
              <a:rPr lang="en-GB" sz="1200" dirty="0"/>
              <a:t> values were significantly different from the calibrator (</a:t>
            </a:r>
            <a:r>
              <a:rPr lang="en-GB" sz="1200" i="1" dirty="0"/>
              <a:t>p</a:t>
            </a:r>
            <a:r>
              <a:rPr lang="en-GB" sz="1200" dirty="0"/>
              <a:t>&lt; 0.01; Student’s </a:t>
            </a:r>
            <a:r>
              <a:rPr lang="en-GB" sz="1200" i="1" dirty="0"/>
              <a:t>t</a:t>
            </a:r>
            <a:r>
              <a:rPr lang="en-GB" sz="1200" dirty="0"/>
              <a:t>-test). (D</a:t>
            </a:r>
            <a:r>
              <a:rPr lang="en-US" sz="1200" dirty="0"/>
              <a:t>) The graph displays the concordance between microarray fold change and Real Time RQ values on a linear </a:t>
            </a:r>
            <a:r>
              <a:rPr lang="en-US" sz="1200" dirty="0" smtClean="0"/>
              <a:t>scale.</a:t>
            </a:r>
            <a:endParaRPr lang="it-IT" sz="1200" dirty="0"/>
          </a:p>
        </p:txBody>
      </p:sp>
      <p:grpSp>
        <p:nvGrpSpPr>
          <p:cNvPr id="7" name="Gruppo 6"/>
          <p:cNvGrpSpPr/>
          <p:nvPr/>
        </p:nvGrpSpPr>
        <p:grpSpPr>
          <a:xfrm>
            <a:off x="251520" y="2530796"/>
            <a:ext cx="8640960" cy="3430116"/>
            <a:chOff x="251520" y="2530796"/>
            <a:chExt cx="8640960" cy="3430116"/>
          </a:xfrm>
        </p:grpSpPr>
        <p:pic>
          <p:nvPicPr>
            <p:cNvPr id="3" name="Immagine 2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1520" y="2530796"/>
              <a:ext cx="8640960" cy="343011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" name="CasellaDiTesto 3"/>
            <p:cNvSpPr txBox="1"/>
            <p:nvPr/>
          </p:nvSpPr>
          <p:spPr>
            <a:xfrm rot="19593960">
              <a:off x="1624436" y="5501379"/>
              <a:ext cx="86472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 smtClean="0">
                  <a:latin typeface="Arial" pitchFamily="34" charset="0"/>
                  <a:cs typeface="Arial" pitchFamily="34" charset="0"/>
                </a:rPr>
                <a:t>WRKY 46</a:t>
              </a:r>
              <a:endParaRPr lang="it-IT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730932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179512" y="180082"/>
            <a:ext cx="87434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Figure S3: Microarray validation and concordance with Real Time results </a:t>
            </a:r>
            <a:r>
              <a:rPr lang="en-GB" sz="1200" dirty="0"/>
              <a:t>(E) Relative gene expression analysis 96h following aphid infestation. The graph displays the relative quantity (RQ) of each target gene in infested plants </a:t>
            </a:r>
            <a:r>
              <a:rPr lang="en-US" sz="1200" dirty="0"/>
              <a:t>relative to the calibrator control plants. </a:t>
            </a:r>
            <a:r>
              <a:rPr lang="en-GB" sz="1200" dirty="0"/>
              <a:t>Asterisks indicate that the 2</a:t>
            </a:r>
            <a:r>
              <a:rPr lang="en-GB" sz="1200" baseline="30000" dirty="0"/>
              <a:t>-</a:t>
            </a:r>
            <a:r>
              <a:rPr lang="en-GB" sz="1200" baseline="30000" dirty="0">
                <a:sym typeface="Symbol"/>
              </a:rPr>
              <a:t></a:t>
            </a:r>
            <a:r>
              <a:rPr lang="en-GB" sz="1200" baseline="30000" dirty="0"/>
              <a:t>Ct</a:t>
            </a:r>
            <a:r>
              <a:rPr lang="en-GB" sz="1200" dirty="0"/>
              <a:t> values were significantly different from the calibrator (</a:t>
            </a:r>
            <a:r>
              <a:rPr lang="en-GB" sz="1200" i="1" dirty="0" smtClean="0"/>
              <a:t>p</a:t>
            </a:r>
            <a:r>
              <a:rPr lang="en-GB" sz="1200" dirty="0" smtClean="0"/>
              <a:t>&lt;0.01</a:t>
            </a:r>
            <a:r>
              <a:rPr lang="en-GB" sz="1200" dirty="0"/>
              <a:t>; Student’s </a:t>
            </a:r>
            <a:r>
              <a:rPr lang="en-GB" sz="1200" i="1" dirty="0"/>
              <a:t>t</a:t>
            </a:r>
            <a:r>
              <a:rPr lang="en-GB" sz="1200" dirty="0"/>
              <a:t>-test). (F</a:t>
            </a:r>
            <a:r>
              <a:rPr lang="en-US" sz="1200" dirty="0"/>
              <a:t>) The graph displays the concordance between microarray fold change and Real Time RQ values on a linear scale</a:t>
            </a:r>
            <a:endParaRPr lang="it-IT" sz="1200" dirty="0"/>
          </a:p>
        </p:txBody>
      </p:sp>
      <p:grpSp>
        <p:nvGrpSpPr>
          <p:cNvPr id="5" name="Gruppo 4"/>
          <p:cNvGrpSpPr/>
          <p:nvPr/>
        </p:nvGrpSpPr>
        <p:grpSpPr>
          <a:xfrm>
            <a:off x="395536" y="2180878"/>
            <a:ext cx="8424936" cy="3240360"/>
            <a:chOff x="395536" y="2180878"/>
            <a:chExt cx="8424936" cy="3240360"/>
          </a:xfrm>
        </p:grpSpPr>
        <p:pic>
          <p:nvPicPr>
            <p:cNvPr id="3" name="Immagine 2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5536" y="2180878"/>
              <a:ext cx="8424936" cy="324036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" name="CasellaDiTesto 3"/>
            <p:cNvSpPr txBox="1"/>
            <p:nvPr/>
          </p:nvSpPr>
          <p:spPr>
            <a:xfrm rot="19830675">
              <a:off x="1677078" y="4964729"/>
              <a:ext cx="90215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 smtClean="0">
                  <a:latin typeface="Arial" pitchFamily="34" charset="0"/>
                  <a:cs typeface="Arial" pitchFamily="34" charset="0"/>
                </a:rPr>
                <a:t>WRKY 46</a:t>
              </a:r>
              <a:endParaRPr lang="it-IT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1194240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8</TotalTime>
  <Words>272</Words>
  <Application>Microsoft Office PowerPoint</Application>
  <PresentationFormat>Personalizzato</PresentationFormat>
  <Paragraphs>6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4" baseType="lpstr">
      <vt:lpstr>Tema di Office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ser3</dc:creator>
  <cp:lastModifiedBy>User3</cp:lastModifiedBy>
  <cp:revision>19</cp:revision>
  <dcterms:created xsi:type="dcterms:W3CDTF">2012-11-07T09:36:18Z</dcterms:created>
  <dcterms:modified xsi:type="dcterms:W3CDTF">2013-07-01T13:08:55Z</dcterms:modified>
</cp:coreProperties>
</file>